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FB45DDF-C594-4B22-BA97-8E1C91CB13B4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200" y="365040"/>
            <a:ext cx="788508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200" y="1825200"/>
            <a:ext cx="78850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200" y="4097520"/>
            <a:ext cx="78850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7E54AB27-521C-4C49-BBF1-82D20E4B23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200" y="365040"/>
            <a:ext cx="788508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200" y="1825200"/>
            <a:ext cx="38476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825200"/>
            <a:ext cx="38476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200" y="4097520"/>
            <a:ext cx="38476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097520"/>
            <a:ext cx="38476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0466EDBA-8E86-4642-9D2C-4BF52F970E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200" y="365040"/>
            <a:ext cx="788508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200" y="1825200"/>
            <a:ext cx="2538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4360" y="1825200"/>
            <a:ext cx="2538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0160" y="1825200"/>
            <a:ext cx="2538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200" y="4097520"/>
            <a:ext cx="2538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4360" y="4097520"/>
            <a:ext cx="2538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0160" y="4097520"/>
            <a:ext cx="253872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EF5B346-633D-448A-979F-DF8C0C9FB5B4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200" y="365040"/>
            <a:ext cx="788508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200" y="1825200"/>
            <a:ext cx="7885080" cy="434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2395F53E-B15B-42EC-9B01-2C337E68FA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200" y="365040"/>
            <a:ext cx="788508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200" y="1825200"/>
            <a:ext cx="788508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FBE43C8-63EC-42D1-BC47-9516E8D4BB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200" y="365040"/>
            <a:ext cx="788508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200" y="1825200"/>
            <a:ext cx="384768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825200"/>
            <a:ext cx="384768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1A91274-DEB4-476C-B8EB-CDE9E8231D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200" y="365040"/>
            <a:ext cx="788508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47456AD-8C92-4CCE-B11A-2198FD7330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200" y="365040"/>
            <a:ext cx="7885080" cy="6139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6A9FECE-D536-43F3-ABE8-BC39276C54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200" y="365040"/>
            <a:ext cx="788508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200" y="1825200"/>
            <a:ext cx="38476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825200"/>
            <a:ext cx="384768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200" y="4097520"/>
            <a:ext cx="38476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EE606D16-9385-45C3-9378-C8D8FF2D6D1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200" y="365040"/>
            <a:ext cx="788508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200" y="1825200"/>
            <a:ext cx="384768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825200"/>
            <a:ext cx="38476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097520"/>
            <a:ext cx="38476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10717B8-50E1-4EC9-BD76-9C95ACB7B7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200" y="365040"/>
            <a:ext cx="788508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200" y="1825200"/>
            <a:ext cx="38476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825200"/>
            <a:ext cx="38476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200" y="4097520"/>
            <a:ext cx="7885080" cy="20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781FB9C-E3E4-4210-8E75-D91AF7EC73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200" y="365040"/>
            <a:ext cx="7885080" cy="13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200" y="1825200"/>
            <a:ext cx="7885080" cy="434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160"/>
            <a:ext cx="205596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AU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AU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"/>
          <p:cNvSpPr/>
          <p:nvPr/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6458040" y="6356160"/>
            <a:ext cx="2055600" cy="363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AU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6DFE0F92-786D-479F-B1B1-0CEF3F42E7D0}" type="slidenum">
              <a:rPr b="0" lang="en-AU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4786200" y="1227240"/>
            <a:ext cx="2090880" cy="167148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6899400" y="1227240"/>
            <a:ext cx="2090520" cy="167148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312840" y="3662280"/>
            <a:ext cx="2090520" cy="167184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tretch/>
        </p:blipFill>
        <p:spPr>
          <a:xfrm>
            <a:off x="2414520" y="3662280"/>
            <a:ext cx="2090880" cy="167184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10131480" y="8058240"/>
            <a:ext cx="1440" cy="1440"/>
          </a:xfrm>
          <a:prstGeom prst="line">
            <a:avLst/>
          </a:prstGeom>
          <a:ln cap="sq" w="6480">
            <a:solidFill>
              <a:srgbClr val="5b9b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" descr=""/>
          <p:cNvPicPr/>
          <p:nvPr/>
        </p:nvPicPr>
        <p:blipFill>
          <a:blip r:embed="rId5"/>
          <a:stretch/>
        </p:blipFill>
        <p:spPr>
          <a:xfrm>
            <a:off x="352440" y="1228680"/>
            <a:ext cx="2089080" cy="167184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6"/>
          <a:stretch/>
        </p:blipFill>
        <p:spPr>
          <a:xfrm>
            <a:off x="2465280" y="1228680"/>
            <a:ext cx="2089080" cy="167184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398520" y="2830680"/>
            <a:ext cx="137880" cy="1440"/>
          </a:xfrm>
          <a:prstGeom prst="line">
            <a:avLst/>
          </a:prstGeom>
          <a:ln cap="sq"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"/>
          <p:cNvSpPr/>
          <p:nvPr/>
        </p:nvSpPr>
        <p:spPr>
          <a:xfrm>
            <a:off x="1029600" y="870120"/>
            <a:ext cx="287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No primary antibody control for Fig.1a-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"/>
          <p:cNvSpPr/>
          <p:nvPr/>
        </p:nvSpPr>
        <p:spPr>
          <a:xfrm>
            <a:off x="303840" y="2619360"/>
            <a:ext cx="52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AU" sz="800" spc="-1" strike="noStrike">
                <a:solidFill>
                  <a:srgbClr val="ffffff"/>
                </a:solidFill>
                <a:latin typeface="Arial"/>
                <a:ea typeface="Arial"/>
              </a:rPr>
              <a:t>100 µ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"/>
          <p:cNvSpPr/>
          <p:nvPr/>
        </p:nvSpPr>
        <p:spPr>
          <a:xfrm>
            <a:off x="5555880" y="870120"/>
            <a:ext cx="2864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No primary antibody control for Fig.1c-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"/>
          <p:cNvSpPr/>
          <p:nvPr/>
        </p:nvSpPr>
        <p:spPr>
          <a:xfrm>
            <a:off x="1059840" y="3341520"/>
            <a:ext cx="273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No primary antibody control for Fig.1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3" name="" descr=""/>
          <p:cNvPicPr/>
          <p:nvPr/>
        </p:nvPicPr>
        <p:blipFill>
          <a:blip r:embed="rId7"/>
          <a:stretch/>
        </p:blipFill>
        <p:spPr>
          <a:xfrm>
            <a:off x="4772160" y="3662280"/>
            <a:ext cx="2089080" cy="167184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8"/>
          <a:stretch/>
        </p:blipFill>
        <p:spPr>
          <a:xfrm>
            <a:off x="6875640" y="3662280"/>
            <a:ext cx="2090520" cy="167184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5529960" y="3341520"/>
            <a:ext cx="283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AU" sz="1200" spc="-1" strike="noStrike">
                <a:solidFill>
                  <a:srgbClr val="000000"/>
                </a:solidFill>
                <a:latin typeface="Arial"/>
                <a:ea typeface="Arial"/>
              </a:rPr>
              <a:t>No primary antibody control for Fig.1f-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"/>
          <p:cNvSpPr/>
          <p:nvPr/>
        </p:nvSpPr>
        <p:spPr>
          <a:xfrm>
            <a:off x="139680" y="203040"/>
            <a:ext cx="104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400" spc="-1" strike="noStrike">
                <a:solidFill>
                  <a:srgbClr val="000000"/>
                </a:solidFill>
                <a:latin typeface="Arial"/>
                <a:ea typeface="Arial"/>
              </a:rPr>
              <a:t>Figure. S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"/>
          <p:cNvSpPr/>
          <p:nvPr/>
        </p:nvSpPr>
        <p:spPr>
          <a:xfrm>
            <a:off x="363600" y="12463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400" spc="-1" strike="noStrike">
                <a:solidFill>
                  <a:srgbClr val="ffffff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"/>
          <p:cNvSpPr/>
          <p:nvPr/>
        </p:nvSpPr>
        <p:spPr>
          <a:xfrm>
            <a:off x="2503440" y="123660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400" spc="-1" strike="noStrike">
                <a:solidFill>
                  <a:srgbClr val="ffffff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"/>
          <p:cNvSpPr/>
          <p:nvPr/>
        </p:nvSpPr>
        <p:spPr>
          <a:xfrm>
            <a:off x="4808520" y="12589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400" spc="-1" strike="noStrike">
                <a:solidFill>
                  <a:srgbClr val="ffffff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"/>
          <p:cNvSpPr/>
          <p:nvPr/>
        </p:nvSpPr>
        <p:spPr>
          <a:xfrm>
            <a:off x="6926400" y="124452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400" spc="-1" strike="noStrike">
                <a:solidFill>
                  <a:srgbClr val="ffffff"/>
                </a:solidFill>
                <a:latin typeface="Arial"/>
                <a:ea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"/>
          <p:cNvSpPr/>
          <p:nvPr/>
        </p:nvSpPr>
        <p:spPr>
          <a:xfrm>
            <a:off x="328680" y="368784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400" spc="-1" strike="noStrike">
                <a:solidFill>
                  <a:srgbClr val="ffffff"/>
                </a:solidFill>
                <a:latin typeface="Arial"/>
                <a:ea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"/>
          <p:cNvSpPr/>
          <p:nvPr/>
        </p:nvSpPr>
        <p:spPr>
          <a:xfrm>
            <a:off x="2450880" y="3679920"/>
            <a:ext cx="24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400" spc="-1" strike="noStrike">
                <a:solidFill>
                  <a:srgbClr val="ffffff"/>
                </a:solidFill>
                <a:latin typeface="Arial"/>
                <a:ea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"/>
          <p:cNvSpPr/>
          <p:nvPr/>
        </p:nvSpPr>
        <p:spPr>
          <a:xfrm>
            <a:off x="4789440" y="36860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400" spc="-1" strike="noStrike">
                <a:solidFill>
                  <a:srgbClr val="ffffff"/>
                </a:solidFill>
                <a:latin typeface="Arial"/>
                <a:ea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"/>
          <p:cNvSpPr/>
          <p:nvPr/>
        </p:nvSpPr>
        <p:spPr>
          <a:xfrm>
            <a:off x="6912000" y="370368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400" spc="-1" strike="noStrike">
                <a:solidFill>
                  <a:srgbClr val="ffffff"/>
                </a:solidFill>
                <a:latin typeface="Arial"/>
                <a:ea typeface="Arial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"/>
          <p:cNvSpPr/>
          <p:nvPr/>
        </p:nvSpPr>
        <p:spPr>
          <a:xfrm>
            <a:off x="3997440" y="123516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200" spc="-1" strike="noStrike">
                <a:solidFill>
                  <a:srgbClr val="ffffff"/>
                </a:solidFill>
                <a:latin typeface="Arial"/>
                <a:ea typeface="Arial"/>
              </a:rPr>
              <a:t>FIT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"/>
          <p:cNvSpPr/>
          <p:nvPr/>
        </p:nvSpPr>
        <p:spPr>
          <a:xfrm>
            <a:off x="8437680" y="124452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200" spc="-1" strike="noStrike">
                <a:solidFill>
                  <a:srgbClr val="ffffff"/>
                </a:solidFill>
                <a:latin typeface="Arial"/>
                <a:ea typeface="Arial"/>
              </a:rPr>
              <a:t>FIT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"/>
          <p:cNvSpPr/>
          <p:nvPr/>
        </p:nvSpPr>
        <p:spPr>
          <a:xfrm>
            <a:off x="3944880" y="368784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200" spc="-1" strike="noStrike">
                <a:solidFill>
                  <a:srgbClr val="ffffff"/>
                </a:solidFill>
                <a:latin typeface="Arial"/>
                <a:ea typeface="Arial"/>
              </a:rPr>
              <a:t>FIT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"/>
          <p:cNvSpPr/>
          <p:nvPr/>
        </p:nvSpPr>
        <p:spPr>
          <a:xfrm>
            <a:off x="8420040" y="367992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200" spc="-1" strike="noStrike">
                <a:solidFill>
                  <a:srgbClr val="ffffff"/>
                </a:solidFill>
                <a:latin typeface="Arial"/>
                <a:ea typeface="Arial"/>
              </a:rPr>
              <a:t>FIT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"/>
          <p:cNvSpPr/>
          <p:nvPr/>
        </p:nvSpPr>
        <p:spPr>
          <a:xfrm>
            <a:off x="1880280" y="125892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200" spc="-1" strike="noStrike">
                <a:solidFill>
                  <a:srgbClr val="ffffff"/>
                </a:solidFill>
                <a:latin typeface="Arial"/>
                <a:ea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"/>
          <p:cNvSpPr/>
          <p:nvPr/>
        </p:nvSpPr>
        <p:spPr>
          <a:xfrm>
            <a:off x="6306120" y="124632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200" spc="-1" strike="noStrike">
                <a:solidFill>
                  <a:srgbClr val="ffffff"/>
                </a:solidFill>
                <a:latin typeface="Arial"/>
                <a:ea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"/>
          <p:cNvSpPr/>
          <p:nvPr/>
        </p:nvSpPr>
        <p:spPr>
          <a:xfrm>
            <a:off x="1824840" y="369108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200" spc="-1" strike="noStrike">
                <a:solidFill>
                  <a:srgbClr val="ffffff"/>
                </a:solidFill>
                <a:latin typeface="Arial"/>
                <a:ea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"/>
          <p:cNvSpPr/>
          <p:nvPr/>
        </p:nvSpPr>
        <p:spPr>
          <a:xfrm>
            <a:off x="6271200" y="369396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1" lang="en-AU" sz="1200" spc="-1" strike="noStrike">
                <a:solidFill>
                  <a:srgbClr val="ffffff"/>
                </a:solidFill>
                <a:latin typeface="Arial"/>
                <a:ea typeface="Arial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1-10T00:42:26Z</dcterms:created>
  <dc:creator>Bandara, Maudella Mudiyanselage Nadeeka</dc:creator>
  <dc:description/>
  <dc:language>en-US</dc:language>
  <cp:lastModifiedBy>Bandara, Maudella Mudiyanselage Nadeeka</cp:lastModifiedBy>
  <dcterms:modified xsi:type="dcterms:W3CDTF">2016-11-11T03:31:10Z</dcterms:modified>
  <cp:revision>19</cp:revision>
  <dc:subject/>
  <dc:title>PowerPoint Presentation</dc:title>
</cp:coreProperties>
</file>